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handoutMasterIdLst>
    <p:handoutMasterId r:id="rId11"/>
  </p:handoutMasterIdLst>
  <p:sldIdLst>
    <p:sldId id="322" r:id="rId2"/>
    <p:sldId id="317" r:id="rId3"/>
    <p:sldId id="320" r:id="rId4"/>
    <p:sldId id="318" r:id="rId5"/>
    <p:sldId id="321" r:id="rId6"/>
    <p:sldId id="341" r:id="rId7"/>
    <p:sldId id="299" r:id="rId8"/>
    <p:sldId id="347" r:id="rId9"/>
  </p:sldIdLst>
  <p:sldSz cx="6858000" cy="9144000" type="screen4x3"/>
  <p:notesSz cx="6797675" cy="9926638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Partners Information Systems" initials="IS" lastIdx="3" clrIdx="0"/>
  <p:cmAuthor id="1" name="Owner" initials="O" lastIdx="2" clrIdx="1"/>
  <p:cmAuthor id="2" name="Bernadette Fernandez" initials="BF" lastIdx="2" clrIdx="2"/>
  <p:cmAuthor id="3" name="WMZ" initials="W" lastIdx="1" clrIdx="3"/>
  <p:cmAuthor id="4" name="Yasuko Nagasaka" initials="" lastIdx="1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0226BE"/>
    <a:srgbClr val="009900"/>
    <a:srgbClr val="339933"/>
    <a:srgbClr val="33CC33"/>
    <a:srgbClr val="9900CC"/>
    <a:srgbClr val="CC00FF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538" autoAdjust="0"/>
    <p:restoredTop sz="94660" autoAdjust="0"/>
  </p:normalViewPr>
  <p:slideViewPr>
    <p:cSldViewPr>
      <p:cViewPr varScale="1">
        <p:scale>
          <a:sx n="91" d="100"/>
          <a:sy n="91" d="100"/>
        </p:scale>
        <p:origin x="1374" y="90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commentAuthors" Target="commentAuthors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CF12075F-01AD-4E90-A14D-7DC05920B969}" type="datetimeFigureOut">
              <a:rPr lang="en-US" smtClean="0"/>
              <a:pPr/>
              <a:t>8/13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8584"/>
            <a:ext cx="2945659" cy="496332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50443" y="9428584"/>
            <a:ext cx="2945659" cy="496332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5B73E030-F330-40D3-91A7-0BEC73FD9B0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985902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474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6661" tIns="48331" rIns="96661" bIns="48331" numCol="1" anchor="t" anchorCtr="0" compatLnSpc="1">
            <a:prstTxWarp prst="textNoShape">
              <a:avLst/>
            </a:prstTxWarp>
          </a:bodyPr>
          <a:lstStyle>
            <a:lvl1pPr>
              <a:defRPr sz="1300">
                <a:latin typeface="Calibri" pitchFamily="34" charset="0"/>
              </a:defRPr>
            </a:lvl1pPr>
          </a:lstStyle>
          <a:p>
            <a:endParaRPr lang="en-US"/>
          </a:p>
        </p:txBody>
      </p:sp>
      <p:sp>
        <p:nvSpPr>
          <p:cNvPr id="105475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50443" y="0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6661" tIns="48331" rIns="96661" bIns="48331" numCol="1" anchor="t" anchorCtr="0" compatLnSpc="1">
            <a:prstTxWarp prst="textNoShape">
              <a:avLst/>
            </a:prstTxWarp>
          </a:bodyPr>
          <a:lstStyle>
            <a:lvl1pPr algn="r">
              <a:defRPr sz="1300">
                <a:latin typeface="Calibri" pitchFamily="34" charset="0"/>
              </a:defRPr>
            </a:lvl1pPr>
          </a:lstStyle>
          <a:p>
            <a:fld id="{EF57B98A-8361-439F-9695-B9CED2E6E074}" type="datetimeFigureOut">
              <a:rPr lang="en-US"/>
              <a:pPr/>
              <a:t>8/13/2018</a:t>
            </a:fld>
            <a:endParaRPr lang="en-US"/>
          </a:p>
        </p:txBody>
      </p:sp>
      <p:sp>
        <p:nvSpPr>
          <p:cNvPr id="105476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003425" y="744538"/>
            <a:ext cx="2790825" cy="3722687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</p:spPr>
      </p:sp>
      <p:sp>
        <p:nvSpPr>
          <p:cNvPr id="105477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679768" y="4715153"/>
            <a:ext cx="5438140" cy="44669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6661" tIns="48331" rIns="96661" bIns="48331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5478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9428584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6661" tIns="48331" rIns="96661" bIns="48331" numCol="1" anchor="b" anchorCtr="0" compatLnSpc="1">
            <a:prstTxWarp prst="textNoShape">
              <a:avLst/>
            </a:prstTxWarp>
          </a:bodyPr>
          <a:lstStyle>
            <a:lvl1pPr>
              <a:defRPr sz="1300">
                <a:latin typeface="Calibri" pitchFamily="34" charset="0"/>
              </a:defRPr>
            </a:lvl1pPr>
          </a:lstStyle>
          <a:p>
            <a:endParaRPr lang="en-US"/>
          </a:p>
        </p:txBody>
      </p:sp>
      <p:sp>
        <p:nvSpPr>
          <p:cNvPr id="105479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50443" y="9428584"/>
            <a:ext cx="2945659" cy="496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6661" tIns="48331" rIns="96661" bIns="48331" numCol="1" anchor="b" anchorCtr="0" compatLnSpc="1">
            <a:prstTxWarp prst="textNoShape">
              <a:avLst/>
            </a:prstTxWarp>
          </a:bodyPr>
          <a:lstStyle>
            <a:lvl1pPr algn="r">
              <a:defRPr sz="1300">
                <a:latin typeface="Calibri" pitchFamily="34" charset="0"/>
              </a:defRPr>
            </a:lvl1pPr>
          </a:lstStyle>
          <a:p>
            <a:fld id="{3C172784-0AC3-44B5-AC6D-B37EBEC3550A}" type="slidenum">
              <a:rPr lang="en-US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2397261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Calibri" pitchFamily="34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61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11619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766287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42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12643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841509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666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13667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173213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690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14691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95928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714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15715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732456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738" name="Rectangle 2"/>
          <p:cNvSpPr>
            <a:spLocks noGrp="1" noRot="1" noChangeAspect="1" noChangeArrowheads="1" noTextEdit="1"/>
          </p:cNvSpPr>
          <p:nvPr>
            <p:ph type="sldImg"/>
          </p:nvPr>
        </p:nvSpPr>
        <p:spPr>
          <a:ln/>
        </p:spPr>
      </p:sp>
      <p:sp>
        <p:nvSpPr>
          <p:cNvPr id="116739" name="Rectangle 3"/>
          <p:cNvSpPr>
            <a:spLocks noGrp="1" noChangeArrowheads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08895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6BADD8F-5D53-4378-AA38-085AE45A1B9E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798128-99D8-4827-9424-017760FE757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9F78FE-DB5D-4BD5-8506-D0657C0933BF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D16642F-EDB6-4228-8257-266BA6F9BE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A17FE5-2C1F-45B0-98FA-9215A876FCE5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27FA50-431C-495D-ADFA-850A87A9E3B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2FFBE5-3C74-4EBD-ABEC-3115D776B3BA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2C5F13B-287F-45C1-B296-8A2745B3500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625A429-6F71-47F2-9BC0-689048D3746E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F798D6B-907A-43CD-8F46-DE95EEF67413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BB95A04-980A-478A-A56E-534738CF5D7D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BB2728-F239-4D31-9EC2-3CF1BDC6217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E2D0D7-8A8C-4E60-BAD4-F53F4207608E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A47BC51-5721-4E49-9E53-9C153EE22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ABD7AFF-3BBE-4D3E-9AB1-B1882C1A97C6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3724D3-431E-4067-BC32-BD4A1AEBAD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E33308-6FFE-4776-A867-82CF4798D2FD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4EC375-84DB-4A59-BD95-7531E40D14E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060481-E3F8-4EBC-B612-D35EFA983B0A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706D20A-5A4E-4635-B963-BB31D45B80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9C0A59-CA4C-4170-A4F7-297D0CEB2C9D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6D0965-0EC1-4003-A077-17939E2F0D1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E3B08F18-120A-4676-9485-42483BCD0636}" type="datetimeFigureOut">
              <a:rPr lang="en-US"/>
              <a:pPr>
                <a:defRPr/>
              </a:pPr>
              <a:t>8/13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95D1A6D5-0C17-4EC8-92D1-9E1980999F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6.xml"/><Relationship Id="rId7" Type="http://schemas.openxmlformats.org/officeDocument/2006/relationships/image" Target="../media/image3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342900" y="2971800"/>
            <a:ext cx="6172200" cy="1524000"/>
          </a:xfrm>
          <a:prstGeom prst="rect">
            <a:avLst/>
          </a:prstGeom>
        </p:spPr>
        <p:txBody>
          <a:bodyPr anchor="ctr"/>
          <a:lstStyle/>
          <a:p>
            <a:pPr algn="ctr" fontAlgn="auto">
              <a:spcAft>
                <a:spcPts val="0"/>
              </a:spcAft>
              <a:defRPr/>
            </a:pPr>
            <a:r>
              <a:rPr lang="en-US" sz="4400" dirty="0">
                <a:latin typeface="+mj-lt"/>
                <a:ea typeface="+mj-ea"/>
                <a:cs typeface="+mj-cs"/>
              </a:rPr>
              <a:t>Supplemental </a:t>
            </a:r>
          </a:p>
          <a:p>
            <a:pPr algn="ctr" fontAlgn="auto">
              <a:spcAft>
                <a:spcPts val="0"/>
              </a:spcAft>
              <a:defRPr/>
            </a:pPr>
            <a:r>
              <a:rPr lang="en-US" sz="4400" dirty="0">
                <a:latin typeface="+mj-lt"/>
                <a:ea typeface="+mj-ea"/>
                <a:cs typeface="+mj-cs"/>
              </a:rPr>
              <a:t>tables and figures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32029275"/>
              </p:ext>
            </p:extLst>
          </p:nvPr>
        </p:nvGraphicFramePr>
        <p:xfrm>
          <a:off x="304802" y="777313"/>
          <a:ext cx="6248397" cy="7354722"/>
        </p:xfrm>
        <a:graphic>
          <a:graphicData uri="http://schemas.openxmlformats.org/drawingml/2006/table">
            <a:tbl>
              <a:tblPr/>
              <a:tblGrid>
                <a:gridCol w="46501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8977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649201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64920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649201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649201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649201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649201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649201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649201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</a:tblGrid>
              <a:tr h="97415">
                <a:tc rowSpan="2"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RBC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lasma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97415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ite (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ate (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RSNO 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n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NNO (nM)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O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hem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n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itrite (</a:t>
                      </a:r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itrate (</a:t>
                      </a:r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RXNO 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n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97415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min</a:t>
                      </a:r>
                    </a:p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(NO 60 min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3 ±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1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7 ± 29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130 ± 902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615 ± 916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74 ± 91*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0 ± 0.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3 ± 34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679 ± 61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047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2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1.0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4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310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97415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 ± 0.2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8.7 ± 4.8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14 ± 216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66 ± 217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6 ± 57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 ± 0.2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6 ± 20*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482 ± 171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1.000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29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2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9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97415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 ± 0.2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7.7 ± 4.2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65 ± 67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97 ± 47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32 ± 59*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7 ± 0.3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8.9 ± 5.2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89 ± 382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6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0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82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06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0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792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97415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0 mi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4 ± 0.2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5.1 ± 11.3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33 ± 60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55 ± 77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8.0 ± 25.2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3± 0.6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5.8 ± 9.1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32 ± 293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48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4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13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1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34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9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97415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0 mi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3 ± 0.1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.8 ± 2.0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98 ± 100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2 ± 40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9.6 ± 15.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 ± 0.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5.7 ± 1.7*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585 ± 272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08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48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421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95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19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2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97415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20 mi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 ± 0.2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9.7 ± 11.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32 ± 159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45 ± 87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1.8 ± 9.5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4 ± 0.4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.8 ± 1.0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997 ± 57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74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62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47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78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78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35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97415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440 mi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3 ± 0.2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1.2 ± 6.2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92 ± 110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62 ± 51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7.7 ± 3.3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5 ± 0.5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.1 ± 1.3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331 ± 505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62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310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56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.55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421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451774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2880 m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1.8 ± 0.2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34.6 ± 8.4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rgbClr val="FF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1097 ±</a:t>
                      </a:r>
                      <a:r>
                        <a:rPr lang="en-US" sz="1200" b="0" i="0" u="none" strike="noStrike" baseline="0" dirty="0" smtClean="0">
                          <a:solidFill>
                            <a:schemeClr val="tx1"/>
                          </a:solidFill>
                          <a:latin typeface="+mn-lt"/>
                        </a:rPr>
                        <a:t> 156</a:t>
                      </a:r>
                      <a:endParaRPr lang="en-US" sz="1200" b="0" i="0" u="none" strike="noStrike" dirty="0" smtClean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75 ± 56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47.5 ± 6.3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rgbClr val="FF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2.6 ± 0.4</a:t>
                      </a:r>
                    </a:p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5.8 ± 0.7*</a:t>
                      </a:r>
                    </a:p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200" b="0" i="0" u="none" strike="noStrike" dirty="0" smtClean="0">
                        <a:solidFill>
                          <a:srgbClr val="FF0000"/>
                        </a:solidFill>
                        <a:latin typeface="+mn-lt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2530 ± 433</a:t>
                      </a: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76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08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32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1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76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0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24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97415"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97415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Air 60 m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0 ± 0.3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2.1 ± 8.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04 ± 128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8 ± 5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4.9 ± 3.8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2 ± 0.69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.1 ± 0.9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555 ± 83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9741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</a:tbl>
          </a:graphicData>
        </a:graphic>
      </p:graphicFrame>
      <p:sp>
        <p:nvSpPr>
          <p:cNvPr id="7" name="Title 1"/>
          <p:cNvSpPr txBox="1">
            <a:spLocks/>
          </p:cNvSpPr>
          <p:nvPr/>
        </p:nvSpPr>
        <p:spPr bwMode="auto">
          <a:xfrm>
            <a:off x="0" y="0"/>
            <a:ext cx="3810000" cy="776288"/>
          </a:xfrm>
          <a:prstGeom prst="rect">
            <a:avLst/>
          </a:prstGeom>
        </p:spPr>
        <p:txBody>
          <a:bodyPr>
            <a:normAutofit/>
          </a:bodyPr>
          <a:lstStyle/>
          <a:p>
            <a:pPr fontAlgn="auto">
              <a:spcAft>
                <a:spcPts val="0"/>
              </a:spcAft>
              <a:defRPr/>
            </a:pPr>
            <a:r>
              <a:rPr lang="en-US" sz="2400" b="1" dirty="0">
                <a:latin typeface="+mj-lt"/>
                <a:ea typeface="+mj-ea"/>
                <a:cs typeface="+mj-cs"/>
              </a:rPr>
              <a:t>Supplemental Table 1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720759522"/>
              </p:ext>
            </p:extLst>
          </p:nvPr>
        </p:nvGraphicFramePr>
        <p:xfrm>
          <a:off x="152404" y="766225"/>
          <a:ext cx="6553192" cy="7482182"/>
        </p:xfrm>
        <a:graphic>
          <a:graphicData uri="http://schemas.openxmlformats.org/drawingml/2006/table">
            <a:tbl>
              <a:tblPr/>
              <a:tblGrid>
                <a:gridCol w="470889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551903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5304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53040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53040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53040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553040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553040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553040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53040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53040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553040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</a:tblGrid>
              <a:tr h="115153">
                <a:tc rowSpan="2"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Heart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Lungs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08427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itrite (</a:t>
                      </a:r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itrate (</a:t>
                      </a:r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RSNO 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n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RNNO 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n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O-heme (nM)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ite (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ate (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SNO (nM)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NNO (nM)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O-heme (nM)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15153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 min</a:t>
                      </a:r>
                    </a:p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(NO 60 min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2 ± 0.7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6.9 ± 4.7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9 ± 64*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6.5 ± 6.8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4 ± 27*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3 ±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1.1 ± 9.9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7 ± 76*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8.5 ± 24.8*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7.4 ± 14.9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64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7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48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49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2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15153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 mi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0 ± 1.2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6.7 ± 14.8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3.1 ± 6.0*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1.0 ± 7.5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8.6 ± 14.4*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9 ± 0.3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5.4 ± 23.8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47 ± 41*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5.8 ± 5.6*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6.5 ± 1.3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8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8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13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0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57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15153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 mi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6 ± 1.1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8.4 ±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3.9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3.3 ± 4.6*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7.1 ± 3.0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4.6 ± 4.1*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5 ± 0.4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8.1 ± 3.2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3 ± 23*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3.8 ± 7.3*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.6 ± 2.1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62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0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29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7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85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62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9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29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15153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0 mi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.6 ± 2.4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9.9 ± 30.9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7.7 ± 19.3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4.8 ± 3.8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8.0 ± 20.3*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.0 ± 1.0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.8 ± 5.5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8 ± 18*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2.1 ± 4.1*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2.8 ± 26.8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00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5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28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2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43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8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15153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80 mi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6 ± 0.6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3.5 ± 5.4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.1 ± 3.7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9.1 ± 10.6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7.4 ± 2.6*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3 ±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1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.6 ± 6.5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5.2 ± 8.0*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6.5 ± 7.1*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.0 ± 1.6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10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2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2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2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15153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20 mi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 ± 1.1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4.7 ± 7.3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.4 ± 5.3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0.4 ± 7.0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9.6 ± 5.3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5 ± 0.7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4.6 ± 11.7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5.8 ± 6.6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6.2 ± 4.9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7.1 ± 18.3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56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13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2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30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13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48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02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115153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440 mi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.7 ± 0.5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6.3 ± 9.1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.5 ± 3.8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.3 ± 2.2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8.6 ± 6.4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6 ± 0.4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.3 ± 4.9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5.7 ± 7.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2.2 ± 4.4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.8 ± 2.5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42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623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4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421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548</a:t>
                      </a: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15153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2880 m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4.8 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± 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0.9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44.3 ± 16.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30.0 ± 6.0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40.3 ± 5.0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37.1 ± 4.2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2.2 ± 0.6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26.9 ± 3.5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23.1 ± 7.6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37.2 ± 5.3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15.4 ± 2.0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6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25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79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329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5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17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76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93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08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66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115153"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758" marR="5758" marT="5758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115153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ir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0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i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.2 ± 1.4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3.9 ± 29.0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4.1 ± 6.6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1.4 ± 6.8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8.4 ± 1.6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.4 ± 0.9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0.8 ± 5.0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0.3 ± 6.6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7.2 ± 3.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1.9 ± 6.1 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11515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</a:tbl>
          </a:graphicData>
        </a:graphic>
      </p:graphicFrame>
      <p:sp>
        <p:nvSpPr>
          <p:cNvPr id="7" name="Title 1"/>
          <p:cNvSpPr txBox="1">
            <a:spLocks/>
          </p:cNvSpPr>
          <p:nvPr/>
        </p:nvSpPr>
        <p:spPr bwMode="auto">
          <a:xfrm>
            <a:off x="0" y="0"/>
            <a:ext cx="3657600" cy="776288"/>
          </a:xfrm>
          <a:prstGeom prst="rect">
            <a:avLst/>
          </a:prstGeom>
        </p:spPr>
        <p:txBody>
          <a:bodyPr>
            <a:normAutofit/>
          </a:bodyPr>
          <a:lstStyle/>
          <a:p>
            <a:pPr fontAlgn="auto">
              <a:spcAft>
                <a:spcPts val="0"/>
              </a:spcAft>
              <a:defRPr/>
            </a:pPr>
            <a:r>
              <a:rPr lang="en-US" sz="2400" b="1" dirty="0">
                <a:latin typeface="+mn-lt"/>
              </a:rPr>
              <a:t>Supplemental </a:t>
            </a:r>
            <a:r>
              <a:rPr lang="en-US" sz="2400" b="1" dirty="0">
                <a:latin typeface="+mj-lt"/>
                <a:ea typeface="+mj-ea"/>
                <a:cs typeface="+mj-cs"/>
              </a:rPr>
              <a:t>Table 2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 txBox="1">
            <a:spLocks/>
          </p:cNvSpPr>
          <p:nvPr/>
        </p:nvSpPr>
        <p:spPr bwMode="auto">
          <a:xfrm>
            <a:off x="0" y="0"/>
            <a:ext cx="4495800" cy="776288"/>
          </a:xfrm>
          <a:prstGeom prst="rect">
            <a:avLst/>
          </a:prstGeom>
        </p:spPr>
        <p:txBody>
          <a:bodyPr>
            <a:normAutofit/>
          </a:bodyPr>
          <a:lstStyle/>
          <a:p>
            <a:pPr fontAlgn="auto">
              <a:spcAft>
                <a:spcPts val="0"/>
              </a:spcAft>
              <a:defRPr/>
            </a:pPr>
            <a:r>
              <a:rPr lang="en-US" sz="2400" b="1" dirty="0">
                <a:latin typeface="+mn-lt"/>
              </a:rPr>
              <a:t>Supplemental </a:t>
            </a:r>
            <a:r>
              <a:rPr lang="en-US" sz="2400" b="1" dirty="0">
                <a:latin typeface="+mj-lt"/>
                <a:ea typeface="+mj-ea"/>
                <a:cs typeface="+mj-cs"/>
              </a:rPr>
              <a:t>Table 3</a:t>
            </a:r>
          </a:p>
        </p:txBody>
      </p:sp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253212"/>
              </p:ext>
            </p:extLst>
          </p:nvPr>
        </p:nvGraphicFramePr>
        <p:xfrm>
          <a:off x="152402" y="784888"/>
          <a:ext cx="6553196" cy="7441590"/>
        </p:xfrm>
        <a:graphic>
          <a:graphicData uri="http://schemas.openxmlformats.org/drawingml/2006/table">
            <a:tbl>
              <a:tblPr/>
              <a:tblGrid>
                <a:gridCol w="504091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734157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578653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26255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26255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26255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52625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526255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52625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26255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  <a:gridCol w="526255">
                  <a:extLst>
                    <a:ext uri="{9D8B030D-6E8A-4147-A177-3AD203B41FA5}">
                      <a16:colId xmlns:a16="http://schemas.microsoft.com/office/drawing/2014/main" xmlns="" val="20010"/>
                    </a:ext>
                  </a:extLst>
                </a:gridCol>
                <a:gridCol w="526255">
                  <a:extLst>
                    <a:ext uri="{9D8B030D-6E8A-4147-A177-3AD203B41FA5}">
                      <a16:colId xmlns:a16="http://schemas.microsoft.com/office/drawing/2014/main" xmlns="" val="20011"/>
                    </a:ext>
                  </a:extLst>
                </a:gridCol>
              </a:tblGrid>
              <a:tr h="85298">
                <a:tc rowSpan="2" gridSpan="2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Liver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Kidney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54390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ite (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ate (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SNO (nM)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NNO (nM)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O-heme (nM)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ite (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ate (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SNO (nM)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NNO (nM)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O-heme (nM)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8529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 min</a:t>
                      </a:r>
                    </a:p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(NO 60 min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.0 ±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2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9.1 ± 7.9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27 ± 193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89 ± 151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38 ± 155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 ± 0.5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7.5 ± 16.9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78 ± 198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0 ± 60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8 ± 25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4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73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2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42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8529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 mi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0 ± 0.4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2.9 ± 8.3*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69 ± 238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30 ± 122*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0 ± 14*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8 ± 0.7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0 ± 11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9 ± 19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6 ± 13*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2.5 ± 6.7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8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9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4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29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8529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0 mi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6 ± 0.3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.0 ± 2.4*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100 ± 107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216 ± 49*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53 ± 18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2 ± 0.9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1.0 ± 10.8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3.1 ± 12.0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3.7 ± 8.3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3.4 ± 3.6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4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9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52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7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4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47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29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8529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0 mi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7 ± 0.4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0.4 ± 16.8 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75 ± 120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29 ± 170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1 ± 70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3 ± 1.7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7 ± 52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1.0 ± 13.3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9.2 ± 2.9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5.4 ± 22.6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8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8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64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64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8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8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13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8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8529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80 mi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2 ± 0.3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5.2 ± 3.7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90 ± 62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25 ± 31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5.4 ± 6.7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6 ± 0.6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2.9 ± 12.0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.4 ± 10.1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6.3 ± 5.8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5.1 ± 3.1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64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32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95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22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4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8529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20 mi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1 ± 0.4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.2 ± 3.5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1 ± 29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3 ± 30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5.3 ± 6.2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5 ± 0.9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1.7 ± 12.2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.1 ± 7.7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6.9 ± 8.4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2.1 ± 4.8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1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5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32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8529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440 mi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2 ± 0.3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.3 ± 4.6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34 ± 37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26 ± 45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3.7 ± 2.9*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3 ± 0.3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1.4 ± 12.3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3.1 ± 7.3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8.6 ± 8.3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2.4 ± 5.8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730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30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8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5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16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730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222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85298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2880 m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1.8 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± 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0.3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17.3 ±</a:t>
                      </a:r>
                      <a:r>
                        <a:rPr lang="en-US" sz="1200" b="0" i="0" u="none" strike="noStrike" baseline="0" dirty="0" smtClean="0">
                          <a:solidFill>
                            <a:schemeClr val="tx1"/>
                          </a:solidFill>
                          <a:latin typeface="Calibri"/>
                        </a:rPr>
                        <a:t> 2.4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194 ± 20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191 ± 19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25.3 ± 2.7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4.7 ± 0.8</a:t>
                      </a:r>
                      <a:r>
                        <a:rPr lang="en-US" sz="1200" b="0" i="0" u="none" strike="noStrike" dirty="0" smtClean="0">
                          <a:solidFill>
                            <a:srgbClr val="C00000"/>
                          </a:solidFill>
                          <a:latin typeface="Calibri"/>
                        </a:rPr>
                        <a:t> </a:t>
                      </a:r>
                      <a:endParaRPr lang="en-US" sz="1200" b="0" i="0" u="none" strike="noStrike" dirty="0">
                        <a:solidFill>
                          <a:srgbClr val="C00000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47.0 ± 9.7</a:t>
                      </a:r>
                      <a:r>
                        <a:rPr lang="en-US" sz="1200" b="0" i="0" u="none" strike="noStrike" dirty="0" smtClean="0">
                          <a:solidFill>
                            <a:srgbClr val="C00000"/>
                          </a:solidFill>
                          <a:latin typeface="Calibri"/>
                        </a:rPr>
                        <a:t> </a:t>
                      </a:r>
                      <a:endParaRPr lang="en-US" sz="1200" b="0" i="0" u="none" strike="noStrike" dirty="0">
                        <a:solidFill>
                          <a:srgbClr val="C00000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24.0 ± 8.9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71.0 ± 6.4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33.7 ± 6.1 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5758" marR="5758" marT="5758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11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914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1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53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93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47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931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1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17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85298"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265" marR="4265" marT="4265" marB="0" anchor="b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85298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ir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0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i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4 ± 0.5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.7 ± 2.3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3 ± 2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3 ± 51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3.8 ± 1.5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.7 ± 1.3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3.5 ± 7.9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.1 ± 8.0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6.6 ± 7.9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9.4 ± 7.3 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85298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4265" marR="4265" marT="4265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itle 1"/>
          <p:cNvSpPr txBox="1">
            <a:spLocks/>
          </p:cNvSpPr>
          <p:nvPr/>
        </p:nvSpPr>
        <p:spPr bwMode="auto">
          <a:xfrm>
            <a:off x="0" y="0"/>
            <a:ext cx="4191000" cy="776288"/>
          </a:xfrm>
          <a:prstGeom prst="rect">
            <a:avLst/>
          </a:prstGeom>
        </p:spPr>
        <p:txBody>
          <a:bodyPr>
            <a:normAutofit/>
          </a:bodyPr>
          <a:lstStyle/>
          <a:p>
            <a:pPr fontAlgn="auto">
              <a:spcAft>
                <a:spcPts val="0"/>
              </a:spcAft>
              <a:defRPr/>
            </a:pPr>
            <a:r>
              <a:rPr lang="en-US" sz="2400" b="1" dirty="0">
                <a:latin typeface="+mn-lt"/>
              </a:rPr>
              <a:t>Supplemental </a:t>
            </a:r>
            <a:r>
              <a:rPr lang="en-US" sz="2400" b="1" dirty="0">
                <a:latin typeface="+mj-lt"/>
                <a:ea typeface="+mj-ea"/>
                <a:cs typeface="+mj-cs"/>
              </a:rPr>
              <a:t>Table 4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4382855"/>
              </p:ext>
            </p:extLst>
          </p:nvPr>
        </p:nvGraphicFramePr>
        <p:xfrm>
          <a:off x="764039" y="770163"/>
          <a:ext cx="5329923" cy="7471331"/>
        </p:xfrm>
        <a:graphic>
          <a:graphicData uri="http://schemas.openxmlformats.org/drawingml/2006/table">
            <a:tbl>
              <a:tblPr/>
              <a:tblGrid>
                <a:gridCol w="43159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3159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499219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566788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56678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566788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566788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566788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566788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566788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</a:tblGrid>
              <a:tr h="108857">
                <a:tc rowSpan="2" gridSpan="3"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 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Brai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Urine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08857">
                <a:tc gridSpan="3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ite (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itrate (</a:t>
                      </a:r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RSNO (nM)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RNNO 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n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O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hem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 (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latin typeface="Calibri"/>
                        </a:rPr>
                        <a:t>nM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)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itrite (</a:t>
                      </a:r>
                      <a:r>
                        <a:rPr lang="el-GR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nitrate (</a:t>
                      </a:r>
                      <a:r>
                        <a:rPr lang="el-GR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μ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)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08857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0 min</a:t>
                      </a:r>
                    </a:p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(NO 60 min)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1 ± 0.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5.4 ± 17.1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84 ± 36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7.8 ± 7.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94 ± 36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6 ± 0.12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873 ± 300*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92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49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21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6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00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08857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0 mi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0 ± 0.7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9.8 ± 19.9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53 ± 65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0.8 ± 6.1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62 ± 41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8 ± 0.1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962 ± 954*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343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5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28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13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38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1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08857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0 mi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9 ± 0.7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9.5 ±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.4 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49 ± 27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94.6 ± 6.9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9 ± 41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98 ± 0.19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238 ± 805*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19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429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82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37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2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08857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60 mi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6 ± 1.0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2.9 ± 13.7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9 ± 53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9.3 ± 13.1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09 ± 52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3 ± 0.16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063 ± 560*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68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8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5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30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833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2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08857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80 mi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.0 ± 0.3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2.0 ± 2.7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57 ± 36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4.7 ± 3.9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25 ± 29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9 ± 0.06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3900 ± 1431*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7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30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48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48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91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47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00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08857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20 mi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5 ± 0.8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7.2 ± 6.2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1 ± 40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86.6 ± 10.2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4 ± 30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73 ± 0.13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44 ± 23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90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91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51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48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548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127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093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108857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440 mi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2.9 ± 0.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.7 ± 2.3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70 ± 16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02 ± 10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35 ± 44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0.67 ± 0.06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164 ± 26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73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6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310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51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841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17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073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08857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2880 mi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endParaRPr lang="en-US" dirty="0"/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Mean ± SEM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+mn-lt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2.9 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± 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0.5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26.3 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± 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6.4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179 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± 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12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103 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± 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9.0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137 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± 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20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0.99 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+mn-lt"/>
                        </a:rPr>
                        <a:t>± 0.16</a:t>
                      </a:r>
                      <a:endParaRPr lang="en-US" sz="1200" b="0" i="0" u="none" strike="noStrike" dirty="0">
                        <a:solidFill>
                          <a:srgbClr val="FF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90.6 </a:t>
                      </a:r>
                      <a:r>
                        <a:rPr lang="en-US" sz="1200" b="0" i="0" u="none" strike="noStrike" dirty="0">
                          <a:solidFill>
                            <a:schemeClr val="tx1"/>
                          </a:solidFill>
                          <a:latin typeface="Calibri"/>
                        </a:rPr>
                        <a:t>± </a:t>
                      </a:r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latin typeface="Calibri"/>
                        </a:rPr>
                        <a:t>12.8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 dirty="0"/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P  </a:t>
                      </a:r>
                    </a:p>
                  </a:txBody>
                  <a:tcPr marL="4871" marR="4871" marT="4871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1.00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610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24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08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42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03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0.61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4871" marR="4871" marT="4871" marB="0" anchor="b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108857"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1200" b="0" i="0" u="none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108857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Air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latin typeface="Calibri"/>
                        </a:rPr>
                        <a:t>60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mi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endParaRPr lang="en-US" sz="1200" b="0" i="0" u="none" strike="noStrike" dirty="0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Mea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.8 ± 0.6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31.4 ± 2.5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214 ± 22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77.5 ± 6.2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187 ± 46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0.55 ± 0.05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7.2 ± 16.7 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10885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N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4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latin typeface="Calibri"/>
                        </a:rPr>
                        <a:t>5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latin typeface="Calibri"/>
                        </a:rPr>
                        <a:t>8</a:t>
                      </a:r>
                    </a:p>
                  </a:txBody>
                  <a:tcPr marL="5443" marR="5443" marT="5443" marB="0" anchor="ctr">
                    <a:lnL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rgbClr r="0" g="0" b="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8975904"/>
              </p:ext>
            </p:extLst>
          </p:nvPr>
        </p:nvGraphicFramePr>
        <p:xfrm>
          <a:off x="228600" y="-57839"/>
          <a:ext cx="5859462" cy="2930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315" name="Prism 7" r:id="rId3" imgW="4976355" imgH="2930213" progId="Prism7.Document">
                  <p:embed/>
                </p:oleObj>
              </mc:Choice>
              <mc:Fallback>
                <p:oleObj name="Prism 7" r:id="rId3" imgW="4976355" imgH="2930213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28600" y="-57839"/>
                        <a:ext cx="5859462" cy="2930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0" y="76200"/>
            <a:ext cx="9154633" cy="5025121"/>
            <a:chOff x="0" y="76200"/>
            <a:chExt cx="9154633" cy="5025121"/>
          </a:xfrm>
        </p:grpSpPr>
        <p:sp>
          <p:nvSpPr>
            <p:cNvPr id="4" name="Title 1"/>
            <p:cNvSpPr txBox="1">
              <a:spLocks/>
            </p:cNvSpPr>
            <p:nvPr/>
          </p:nvSpPr>
          <p:spPr>
            <a:xfrm>
              <a:off x="0" y="76200"/>
              <a:ext cx="3429000" cy="457200"/>
            </a:xfrm>
            <a:prstGeom prst="rect">
              <a:avLst/>
            </a:prstGeom>
          </p:spPr>
          <p:txBody>
            <a:bodyPr>
              <a:normAutofit fontScale="85000" lnSpcReduction="20000"/>
            </a:bodyPr>
            <a:lstStyle/>
            <a:p>
              <a:pPr algn="ctr" fontAlgn="auto">
                <a:spcAft>
                  <a:spcPts val="0"/>
                </a:spcAft>
                <a:defRPr/>
              </a:pPr>
              <a:r>
                <a:rPr lang="en-US" sz="3200" b="1" dirty="0">
                  <a:latin typeface="+mj-lt"/>
                  <a:ea typeface="+mj-ea"/>
                  <a:cs typeface="+mj-cs"/>
                </a:rPr>
                <a:t>Supplemental Figure </a:t>
              </a:r>
              <a:r>
                <a:rPr lang="en-US" sz="3200" b="1" dirty="0" smtClean="0">
                  <a:latin typeface="+mj-lt"/>
                  <a:ea typeface="+mj-ea"/>
                  <a:cs typeface="+mj-cs"/>
                </a:rPr>
                <a:t>1</a:t>
              </a:r>
              <a:endParaRPr lang="en-US" sz="3200" b="1" dirty="0">
                <a:latin typeface="+mj-lt"/>
                <a:ea typeface="+mj-ea"/>
                <a:cs typeface="+mj-cs"/>
              </a:endParaRPr>
            </a:p>
          </p:txBody>
        </p:sp>
        <p:grpSp>
          <p:nvGrpSpPr>
            <p:cNvPr id="18" name="Group 17"/>
            <p:cNvGrpSpPr/>
            <p:nvPr/>
          </p:nvGrpSpPr>
          <p:grpSpPr>
            <a:xfrm>
              <a:off x="1059271" y="1566446"/>
              <a:ext cx="4647426" cy="524708"/>
              <a:chOff x="1059271" y="1566446"/>
              <a:chExt cx="4647426" cy="524708"/>
            </a:xfrm>
          </p:grpSpPr>
          <p:sp>
            <p:nvSpPr>
              <p:cNvPr id="22" name="TextBox 21"/>
              <p:cNvSpPr txBox="1"/>
              <p:nvPr/>
            </p:nvSpPr>
            <p:spPr>
              <a:xfrm>
                <a:off x="1059271" y="1566446"/>
                <a:ext cx="4647426" cy="338554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sz="1600" b="1" dirty="0" smtClean="0">
                    <a:solidFill>
                      <a:schemeClr val="bg1">
                        <a:lumMod val="75000"/>
                      </a:schemeClr>
                    </a:solidFill>
                  </a:rPr>
                  <a:t>C</a:t>
                </a:r>
                <a:r>
                  <a:rPr lang="en-US" sz="1600" b="1" dirty="0" smtClean="0">
                    <a:solidFill>
                      <a:srgbClr val="C00000"/>
                    </a:solidFill>
                  </a:rPr>
                  <a:t>  </a:t>
                </a:r>
                <a:r>
                  <a:rPr lang="en-US" sz="1600" b="1" dirty="0" smtClean="0"/>
                  <a:t>1                 2       3  4       5         6    7   8        </a:t>
                </a:r>
                <a:endParaRPr lang="en-US" sz="1600" b="1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590800" y="1752600"/>
                <a:ext cx="184731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endParaRPr lang="en-US" sz="1600" b="1" dirty="0"/>
              </a:p>
            </p:txBody>
          </p:sp>
        </p:grpSp>
        <p:grpSp>
          <p:nvGrpSpPr>
            <p:cNvPr id="6" name="Group 5"/>
            <p:cNvGrpSpPr/>
            <p:nvPr/>
          </p:nvGrpSpPr>
          <p:grpSpPr>
            <a:xfrm>
              <a:off x="76200" y="2971800"/>
              <a:ext cx="9078433" cy="2129521"/>
              <a:chOff x="76200" y="2971800"/>
              <a:chExt cx="9078433" cy="2129521"/>
            </a:xfrm>
          </p:grpSpPr>
          <p:sp>
            <p:nvSpPr>
              <p:cNvPr id="16" name="TextBox 15"/>
              <p:cNvSpPr txBox="1"/>
              <p:nvPr/>
            </p:nvSpPr>
            <p:spPr>
              <a:xfrm>
                <a:off x="1447800" y="3285439"/>
                <a:ext cx="7706833" cy="18158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b="1" dirty="0" smtClean="0">
                    <a:latin typeface="Arial" pitchFamily="34" charset="0"/>
                    <a:cs typeface="Arial" pitchFamily="34" charset="0"/>
                  </a:rPr>
                  <a:t>	   </a:t>
                </a:r>
                <a:r>
                  <a:rPr lang="en-US" altLang="ja-JP" sz="1400" b="1" dirty="0" smtClean="0">
                    <a:solidFill>
                      <a:schemeClr val="bg1">
                        <a:lumMod val="75000"/>
                      </a:schemeClr>
                    </a:solidFill>
                    <a:latin typeface="Arial" pitchFamily="34" charset="0"/>
                    <a:cs typeface="Arial" pitchFamily="34" charset="0"/>
                  </a:rPr>
                  <a:t>C</a:t>
                </a:r>
                <a:r>
                  <a:rPr lang="en-US" altLang="ja-JP" sz="1400" b="1" dirty="0" smtClean="0">
                    <a:latin typeface="Arial" pitchFamily="34" charset="0"/>
                    <a:cs typeface="Arial" pitchFamily="34" charset="0"/>
                  </a:rPr>
                  <a:t>: 0 min (Air 60 min)		</a:t>
                </a:r>
              </a:p>
              <a:p>
                <a:endParaRPr lang="en-US" sz="1400" b="1" dirty="0" smtClean="0">
                  <a:latin typeface="Arial" pitchFamily="34" charset="0"/>
                  <a:cs typeface="Arial" pitchFamily="34" charset="0"/>
                </a:endParaRPr>
              </a:p>
              <a:p>
                <a:r>
                  <a:rPr lang="en-US" sz="1400" b="1" dirty="0" smtClean="0">
                    <a:latin typeface="Arial" pitchFamily="34" charset="0"/>
                    <a:cs typeface="Arial" pitchFamily="34" charset="0"/>
                  </a:rPr>
                  <a:t>1: 0 min (NO </a:t>
                </a:r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60 </a:t>
                </a:r>
                <a:r>
                  <a:rPr lang="en-US" sz="1400" b="1" dirty="0" smtClean="0">
                    <a:latin typeface="Arial" pitchFamily="34" charset="0"/>
                    <a:cs typeface="Arial" pitchFamily="34" charset="0"/>
                  </a:rPr>
                  <a:t>min)</a:t>
                </a:r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		</a:t>
                </a:r>
                <a:r>
                  <a:rPr lang="en-US" sz="1400" b="1" dirty="0" smtClean="0">
                    <a:latin typeface="Arial" pitchFamily="34" charset="0"/>
                    <a:cs typeface="Arial" pitchFamily="34" charset="0"/>
                  </a:rPr>
                  <a:t> </a:t>
                </a:r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5: 180 </a:t>
                </a:r>
                <a:r>
                  <a:rPr lang="en-US" sz="1400" b="1" dirty="0" smtClean="0">
                    <a:latin typeface="Arial" pitchFamily="34" charset="0"/>
                    <a:cs typeface="Arial" pitchFamily="34" charset="0"/>
                  </a:rPr>
                  <a:t>min</a:t>
                </a:r>
                <a:endParaRPr lang="en-US" sz="1400" b="1" dirty="0">
                  <a:latin typeface="Arial" pitchFamily="34" charset="0"/>
                  <a:cs typeface="Arial" pitchFamily="34" charset="0"/>
                </a:endParaRPr>
              </a:p>
              <a:p>
                <a:r>
                  <a:rPr lang="en-US" sz="1400" b="1" dirty="0" smtClean="0">
                    <a:latin typeface="Arial" pitchFamily="34" charset="0"/>
                    <a:cs typeface="Arial" pitchFamily="34" charset="0"/>
                  </a:rPr>
                  <a:t>2: 10 min 			 </a:t>
                </a:r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6: 720 </a:t>
                </a:r>
                <a:r>
                  <a:rPr lang="en-US" sz="1400" b="1" dirty="0" smtClean="0">
                    <a:latin typeface="Arial" pitchFamily="34" charset="0"/>
                    <a:cs typeface="Arial" pitchFamily="34" charset="0"/>
                  </a:rPr>
                  <a:t>min</a:t>
                </a:r>
                <a:endParaRPr lang="en-US" sz="1400" b="1" dirty="0">
                  <a:latin typeface="Arial" pitchFamily="34" charset="0"/>
                  <a:cs typeface="Arial" pitchFamily="34" charset="0"/>
                </a:endParaRPr>
              </a:p>
              <a:p>
                <a:r>
                  <a:rPr lang="en-US" sz="1400" b="1" dirty="0" smtClean="0">
                    <a:latin typeface="Arial" pitchFamily="34" charset="0"/>
                    <a:cs typeface="Arial" pitchFamily="34" charset="0"/>
                  </a:rPr>
                  <a:t>3: 30 </a:t>
                </a:r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min 			 7: 1440 </a:t>
                </a:r>
                <a:r>
                  <a:rPr lang="en-US" sz="1400" b="1" dirty="0" smtClean="0">
                    <a:latin typeface="Arial" pitchFamily="34" charset="0"/>
                    <a:cs typeface="Arial" pitchFamily="34" charset="0"/>
                  </a:rPr>
                  <a:t>min</a:t>
                </a:r>
                <a:endParaRPr lang="en-US" sz="1400" b="1" dirty="0">
                  <a:latin typeface="Arial" pitchFamily="34" charset="0"/>
                  <a:cs typeface="Arial" pitchFamily="34" charset="0"/>
                </a:endParaRPr>
              </a:p>
              <a:p>
                <a:r>
                  <a:rPr lang="en-US" sz="1400" b="1" dirty="0" smtClean="0">
                    <a:latin typeface="Arial" pitchFamily="34" charset="0"/>
                    <a:cs typeface="Arial" pitchFamily="34" charset="0"/>
                  </a:rPr>
                  <a:t>4: 60 min 			</a:t>
                </a:r>
                <a:r>
                  <a:rPr lang="en-US" sz="1400" b="1" dirty="0">
                    <a:latin typeface="Arial" pitchFamily="34" charset="0"/>
                    <a:cs typeface="Arial" pitchFamily="34" charset="0"/>
                  </a:rPr>
                  <a:t> 8: 2880 min</a:t>
                </a:r>
                <a:endParaRPr lang="en-US" sz="1400" b="1" dirty="0" smtClean="0">
                  <a:latin typeface="Arial" pitchFamily="34" charset="0"/>
                  <a:cs typeface="Arial" pitchFamily="34" charset="0"/>
                </a:endParaRPr>
              </a:p>
              <a:p>
                <a:endParaRPr lang="en-US" sz="1400" b="1" dirty="0" smtClean="0">
                  <a:latin typeface="Arial" pitchFamily="34" charset="0"/>
                  <a:cs typeface="Arial" pitchFamily="34" charset="0"/>
                </a:endParaRPr>
              </a:p>
              <a:p>
                <a:endParaRPr lang="en-US" sz="14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76200" y="2971800"/>
                <a:ext cx="770683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b="1" dirty="0" smtClean="0">
                    <a:latin typeface="Arial" pitchFamily="34" charset="0"/>
                    <a:cs typeface="Arial" pitchFamily="34" charset="0"/>
                  </a:rPr>
                  <a:t>Timing of the NO metabolite level measurements :</a:t>
                </a:r>
                <a:endParaRPr lang="en-US" sz="14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cxnSp>
        <p:nvCxnSpPr>
          <p:cNvPr id="33" name="Straight Arrow Connector 32"/>
          <p:cNvCxnSpPr/>
          <p:nvPr/>
        </p:nvCxnSpPr>
        <p:spPr>
          <a:xfrm>
            <a:off x="1219200" y="1905000"/>
            <a:ext cx="0" cy="186154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/>
          <p:cNvCxnSpPr/>
          <p:nvPr/>
        </p:nvCxnSpPr>
        <p:spPr>
          <a:xfrm>
            <a:off x="1447800" y="1905000"/>
            <a:ext cx="0" cy="186154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/>
          <p:cNvCxnSpPr/>
          <p:nvPr/>
        </p:nvCxnSpPr>
        <p:spPr>
          <a:xfrm>
            <a:off x="2514600" y="1905000"/>
            <a:ext cx="0" cy="186154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3048000" y="1947446"/>
            <a:ext cx="0" cy="186154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/>
          <p:cNvCxnSpPr/>
          <p:nvPr/>
        </p:nvCxnSpPr>
        <p:spPr>
          <a:xfrm>
            <a:off x="3276600" y="1947446"/>
            <a:ext cx="0" cy="186154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>
            <a:off x="3810000" y="1947446"/>
            <a:ext cx="0" cy="186154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/>
          <p:cNvCxnSpPr/>
          <p:nvPr/>
        </p:nvCxnSpPr>
        <p:spPr>
          <a:xfrm>
            <a:off x="4419600" y="1947446"/>
            <a:ext cx="0" cy="186154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4724400" y="1947446"/>
            <a:ext cx="0" cy="186154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/>
          <p:cNvCxnSpPr/>
          <p:nvPr/>
        </p:nvCxnSpPr>
        <p:spPr>
          <a:xfrm>
            <a:off x="5029200" y="1947446"/>
            <a:ext cx="0" cy="186154"/>
          </a:xfrm>
          <a:prstGeom prst="straightConnector1">
            <a:avLst/>
          </a:prstGeom>
          <a:ln>
            <a:solidFill>
              <a:schemeClr val="tx1">
                <a:lumMod val="50000"/>
                <a:lumOff val="50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522609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itle 1"/>
          <p:cNvSpPr txBox="1">
            <a:spLocks/>
          </p:cNvSpPr>
          <p:nvPr/>
        </p:nvSpPr>
        <p:spPr>
          <a:xfrm>
            <a:off x="0" y="76200"/>
            <a:ext cx="3429000" cy="457200"/>
          </a:xfrm>
          <a:prstGeom prst="rect">
            <a:avLst/>
          </a:prstGeom>
        </p:spPr>
        <p:txBody>
          <a:bodyPr>
            <a:normAutofit fontScale="85000" lnSpcReduction="20000"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lang="en-US" sz="3200" b="1" dirty="0">
                <a:latin typeface="+mj-lt"/>
                <a:ea typeface="+mj-ea"/>
                <a:cs typeface="+mj-cs"/>
              </a:rPr>
              <a:t>Supplemental Figure </a:t>
            </a:r>
            <a:r>
              <a:rPr lang="en-US" sz="3200" b="1" dirty="0" smtClean="0">
                <a:latin typeface="+mj-lt"/>
                <a:ea typeface="+mj-ea"/>
                <a:cs typeface="+mj-cs"/>
              </a:rPr>
              <a:t>2</a:t>
            </a:r>
            <a:endParaRPr lang="en-US" sz="3200" b="1" dirty="0">
              <a:latin typeface="+mj-lt"/>
              <a:ea typeface="+mj-ea"/>
              <a:cs typeface="+mj-cs"/>
            </a:endParaRPr>
          </a:p>
        </p:txBody>
      </p:sp>
      <p:grpSp>
        <p:nvGrpSpPr>
          <p:cNvPr id="53290" name="Group 16"/>
          <p:cNvGrpSpPr>
            <a:grpSpLocks/>
          </p:cNvGrpSpPr>
          <p:nvPr/>
        </p:nvGrpSpPr>
        <p:grpSpPr bwMode="auto">
          <a:xfrm>
            <a:off x="1380331" y="1219200"/>
            <a:ext cx="4169570" cy="4413250"/>
            <a:chOff x="1327905" y="1074738"/>
            <a:chExt cx="4170426" cy="4413250"/>
          </a:xfrm>
        </p:grpSpPr>
        <p:graphicFrame>
          <p:nvGraphicFramePr>
            <p:cNvPr id="53286" name="Object 3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932569800"/>
                </p:ext>
              </p:extLst>
            </p:nvPr>
          </p:nvGraphicFramePr>
          <p:xfrm>
            <a:off x="1327905" y="3346451"/>
            <a:ext cx="3783790" cy="21415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3416" name="Prism 7" r:id="rId4" imgW="4729302" imgH="2675945" progId="Prism7.Document">
                    <p:embed/>
                  </p:oleObj>
                </mc:Choice>
                <mc:Fallback>
                  <p:oleObj name="Prism 7" r:id="rId4" imgW="4729302" imgH="2675945" progId="Prism7.Document">
                    <p:embed/>
                    <p:pic>
                      <p:nvPicPr>
                        <p:cNvPr id="0" name="Picture 117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5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327905" y="3346451"/>
                          <a:ext cx="3783790" cy="2141537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 xmlns="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xmlns="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 xmlns="">
                              <a:effectLst>
                                <a:outerShdw blurRad="63500" dist="38097" dir="2700000" algn="ctr" rotWithShape="0">
                                  <a:schemeClr val="bg2">
                                    <a:alpha val="74997"/>
                                  </a:schemeClr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3287" name="Object 39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91582319"/>
                </p:ext>
              </p:extLst>
            </p:nvPr>
          </p:nvGraphicFramePr>
          <p:xfrm>
            <a:off x="1398564" y="1074738"/>
            <a:ext cx="4099767" cy="21399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53417" name="Prism 7" r:id="rId6" imgW="5122570" imgH="2674144" progId="Prism7.Document">
                    <p:embed/>
                  </p:oleObj>
                </mc:Choice>
                <mc:Fallback>
                  <p:oleObj name="Prism 7" r:id="rId6" imgW="5122570" imgH="2674144" progId="Prism7.Document">
                    <p:embed/>
                    <p:pic>
                      <p:nvPicPr>
                        <p:cNvPr id="0" name="Picture 118"/>
                        <p:cNvPicPr>
                          <a:picLocks noChangeAspect="1" noChangeArrowheads="1"/>
                        </p:cNvPicPr>
                        <p:nvPr/>
                      </p:nvPicPr>
                      <p:blipFill>
                        <a:blip r:embed="rId7"/>
                        <a:srcRect/>
                        <a:stretch>
                          <a:fillRect/>
                        </a:stretch>
                      </p:blipFill>
                      <p:spPr bwMode="auto">
                        <a:xfrm>
                          <a:off x="1398564" y="1074738"/>
                          <a:ext cx="4099767" cy="2139950"/>
                        </a:xfrm>
                        <a:prstGeom prst="rect">
                          <a:avLst/>
                        </a:prstGeom>
                        <a:noFill/>
                        <a:ln>
                          <a:noFill/>
                        </a:ln>
                        <a:effectLst/>
                        <a:extLst>
                          <a:ext uri="{909E8E84-426E-40dd-AFC4-6F175D3DCCD1}">
                            <a14:hiddenFill xmlns:a14="http://schemas.microsoft.com/office/drawing/2010/main" xmlns="">
                              <a:solidFill>
                                <a:schemeClr val="accent1"/>
                              </a:solidFill>
                            </a14:hiddenFill>
                          </a:ext>
                          <a:ext uri="{91240B29-F687-4f45-9708-019B960494DF}">
                            <a14:hiddenLine xmlns:a14="http://schemas.microsoft.com/office/drawing/2010/main" xmlns="" w="9525">
                              <a:solidFill>
                                <a:schemeClr val="tx1"/>
                              </a:solidFill>
                              <a:miter lim="800000"/>
                              <a:headEnd/>
                              <a:tailEnd/>
                            </a14:hiddenLine>
                          </a:ext>
                          <a:ext uri="{AF507438-7753-43e0-B8FC-AC1667EBCBE1}">
                            <a14:hiddenEffects xmlns:a14="http://schemas.microsoft.com/office/drawing/2010/main" xmlns="">
                              <a:effectLst>
                                <a:outerShdw blurRad="63500" dist="38097" dir="2700000" algn="ctr" rotWithShape="0">
                                  <a:schemeClr val="bg2">
                                    <a:alpha val="74997"/>
                                  </a:schemeClr>
                                </a:outerShdw>
                              </a:effectLst>
                            </a14:hiddenEffects>
                          </a:ext>
                        </a:extLst>
                      </p:spPr>
                    </p:pic>
                  </p:oleObj>
                </mc:Fallback>
              </mc:AlternateContent>
            </a:graphicData>
          </a:graphic>
        </p:graphicFrame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00200" y="624413"/>
            <a:ext cx="3738391" cy="326652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00201" y="4053412"/>
            <a:ext cx="3760339" cy="4938188"/>
          </a:xfrm>
          <a:prstGeom prst="rect">
            <a:avLst/>
          </a:prstGeom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0" y="76200"/>
            <a:ext cx="3429000" cy="457200"/>
          </a:xfrm>
          <a:prstGeom prst="rect">
            <a:avLst/>
          </a:prstGeom>
        </p:spPr>
        <p:txBody>
          <a:bodyPr>
            <a:normAutofit fontScale="85000" lnSpcReduction="20000"/>
          </a:bodyPr>
          <a:lstStyle/>
          <a:p>
            <a:pPr algn="ctr" fontAlgn="auto">
              <a:spcAft>
                <a:spcPts val="0"/>
              </a:spcAft>
              <a:defRPr/>
            </a:pPr>
            <a:r>
              <a:rPr lang="en-US" sz="3200" b="1" dirty="0">
                <a:latin typeface="+mj-lt"/>
                <a:ea typeface="+mj-ea"/>
                <a:cs typeface="+mj-cs"/>
              </a:rPr>
              <a:t>Supplemental Figure </a:t>
            </a:r>
            <a:r>
              <a:rPr lang="en-US" sz="3200" b="1" dirty="0" smtClean="0">
                <a:latin typeface="+mj-lt"/>
                <a:ea typeface="+mj-ea"/>
                <a:cs typeface="+mj-cs"/>
              </a:rPr>
              <a:t>3</a:t>
            </a:r>
            <a:endParaRPr lang="en-US" sz="3200" b="1" dirty="0">
              <a:latin typeface="+mj-lt"/>
              <a:ea typeface="+mj-ea"/>
              <a:cs typeface="+mj-cs"/>
            </a:endParaRPr>
          </a:p>
        </p:txBody>
      </p:sp>
    </p:spTree>
    <p:extLst>
      <p:ext uri="{BB962C8B-B14F-4D97-AF65-F5344CB8AC3E}">
        <p14:creationId xmlns:p14="http://schemas.microsoft.com/office/powerpoint/2010/main" val="33047989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603</TotalTime>
  <Words>2081</Words>
  <Application>Microsoft Office PowerPoint</Application>
  <PresentationFormat>On-screen Show (4:3)</PresentationFormat>
  <Paragraphs>1118</Paragraphs>
  <Slides>8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ＭＳ Ｐゴシック</vt:lpstr>
      <vt:lpstr>Arial</vt:lpstr>
      <vt:lpstr>Calibri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cp:lastModifiedBy>Anusuyadevi A.</cp:lastModifiedBy>
  <cp:revision>1</cp:revision>
  <cp:lastPrinted>2018-05-02T13:06:12Z</cp:lastPrinted>
  <dcterms:modified xsi:type="dcterms:W3CDTF">2018-08-13T04:56:33Z</dcterms:modified>
</cp:coreProperties>
</file>